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nb-NO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014" autoAdjust="0"/>
    <p:restoredTop sz="94660"/>
  </p:normalViewPr>
  <p:slideViewPr>
    <p:cSldViewPr snapToGrid="0">
      <p:cViewPr varScale="1">
        <p:scale>
          <a:sx n="66" d="100"/>
          <a:sy n="66" d="100"/>
        </p:scale>
        <p:origin x="354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4FA5A3F-93C1-1796-96DC-B773FE36CCD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0CE2584-5399-2C37-3017-2FB617D2E84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nb-NO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66C113E-8CC1-1E36-5E3B-2C056545B1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B2135E-04AA-438E-B6D8-E2B4D8CF5484}" type="datetimeFigureOut">
              <a:rPr lang="nb-NO" smtClean="0"/>
              <a:t>19.12.2024</a:t>
            </a:fld>
            <a:endParaRPr lang="nb-NO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7C51F7E-AF16-F637-6C9F-EE75ADF576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F9130A6-4BF1-264D-2A11-208D5446EC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DB7E0B-4246-46E5-8ABC-BFE1B36A0C8D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0533942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5A9C77B-B779-28A9-4D6A-417ECCB8A56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F31B24C-131F-8D44-5C0A-A468D0B9426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CC686C6-5D65-EC9E-6B35-8EBEF1B3B8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B2135E-04AA-438E-B6D8-E2B4D8CF5484}" type="datetimeFigureOut">
              <a:rPr lang="nb-NO" smtClean="0"/>
              <a:t>19.12.2024</a:t>
            </a:fld>
            <a:endParaRPr lang="nb-NO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1CC458D-EAD6-CB79-FE35-E143C0274C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E5E742D-5A35-3667-A22B-DC56424AC2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DB7E0B-4246-46E5-8ABC-BFE1B36A0C8D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7311134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7DBBA5A-BD26-49AB-F118-0AAE303DF60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D2773FC-A7FC-5596-6D70-EEBF39F8EC5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25F39EE-8DFE-922F-0179-4E63252EA6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B2135E-04AA-438E-B6D8-E2B4D8CF5484}" type="datetimeFigureOut">
              <a:rPr lang="nb-NO" smtClean="0"/>
              <a:t>19.12.2024</a:t>
            </a:fld>
            <a:endParaRPr lang="nb-NO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A853E18-6EBC-6DDD-5CE2-88E462FEEA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6F20306-B3FC-8FB9-0D5D-D0AE1D8A93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DB7E0B-4246-46E5-8ABC-BFE1B36A0C8D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9094334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A679A6D-104B-1224-C5D9-176C09D5808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0AE2962-4555-63DC-F68A-F7933D3A674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32BAD3A-5055-AE18-C950-2D6EA30499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B2135E-04AA-438E-B6D8-E2B4D8CF5484}" type="datetimeFigureOut">
              <a:rPr lang="nb-NO" smtClean="0"/>
              <a:t>19.12.2024</a:t>
            </a:fld>
            <a:endParaRPr lang="nb-NO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86D6D1C-3B6C-D9FD-15B4-8B41D88224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F106CC6-5584-E97F-5C67-4DB85ADE60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DB7E0B-4246-46E5-8ABC-BFE1B36A0C8D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3518826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9765F97-38C3-C07D-769C-1E51A9BC5B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DFAFFA3-F5EA-86CB-D8D3-3CE2077A4D5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9E1DEEE-9546-64DD-2C53-BB73E18020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B2135E-04AA-438E-B6D8-E2B4D8CF5484}" type="datetimeFigureOut">
              <a:rPr lang="nb-NO" smtClean="0"/>
              <a:t>19.12.2024</a:t>
            </a:fld>
            <a:endParaRPr lang="nb-NO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6C96A84-445D-8743-2DD2-3EDDCCFF05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668FAE9-7721-DB83-BD28-794B05297A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DB7E0B-4246-46E5-8ABC-BFE1B36A0C8D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8471959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05A4E25-51CD-9951-3332-FDD6A2389C6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D3D4D20-BED5-99CD-FC9B-03E710E610B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B55A4BC-D1C6-ECDD-D111-A2D19A33326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407CAFB-CF12-B03E-A07C-E430676960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B2135E-04AA-438E-B6D8-E2B4D8CF5484}" type="datetimeFigureOut">
              <a:rPr lang="nb-NO" smtClean="0"/>
              <a:t>19.12.2024</a:t>
            </a:fld>
            <a:endParaRPr lang="nb-NO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C598B0B-C688-6F8C-3F26-D548795549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DA99E08-3D07-E0B3-96F6-A0AB242F27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DB7E0B-4246-46E5-8ABC-BFE1B36A0C8D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7557706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3320C82-A62A-ED0A-9E14-D7DEF4DACDA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BCEDC48-AEFA-135E-C7E7-998B20154AA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67E688A-3918-0B01-3BC3-2FA90900F7F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E02CD1C-A9AA-557C-B111-8AC9E69697F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FF2028C-0DD0-CEEA-2B8D-C53422A187F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BB80607-691D-3FA8-BDBA-9AF812D30B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B2135E-04AA-438E-B6D8-E2B4D8CF5484}" type="datetimeFigureOut">
              <a:rPr lang="nb-NO" smtClean="0"/>
              <a:t>19.12.2024</a:t>
            </a:fld>
            <a:endParaRPr lang="nb-NO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582E73D-CCCA-A57D-7F66-CFA41C4FF7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8FF59F7-FC20-CF5E-5ACE-F36D4B7C83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DB7E0B-4246-46E5-8ABC-BFE1B36A0C8D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2119153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667518-E657-45FA-3BD3-E88109E6369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2C2FF0F-A25A-4218-E561-9DA9B1BE7E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B2135E-04AA-438E-B6D8-E2B4D8CF5484}" type="datetimeFigureOut">
              <a:rPr lang="nb-NO" smtClean="0"/>
              <a:t>19.12.2024</a:t>
            </a:fld>
            <a:endParaRPr lang="nb-NO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FDCDFD9-A79F-98E6-922F-A69F3CA7BD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CA7E227-5852-010D-5E21-75D1151081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DB7E0B-4246-46E5-8ABC-BFE1B36A0C8D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1434064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3DE37EC-943D-EB33-5901-9EBC92467E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B2135E-04AA-438E-B6D8-E2B4D8CF5484}" type="datetimeFigureOut">
              <a:rPr lang="nb-NO" smtClean="0"/>
              <a:t>19.12.2024</a:t>
            </a:fld>
            <a:endParaRPr lang="nb-NO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CC810C3-5CB4-01F1-B6DC-68D061D43B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913FD71-3F69-A1D8-5D9F-FF38543524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DB7E0B-4246-46E5-8ABC-BFE1B36A0C8D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5920459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D6752EB-9117-EEC4-F4D3-CE928F7F551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09E6030-1F21-895F-BA58-3C087985456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CC584FA-1A92-3C95-0BDF-44B35D5EB58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07959EC-A175-95DE-FD6E-14493786A8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B2135E-04AA-438E-B6D8-E2B4D8CF5484}" type="datetimeFigureOut">
              <a:rPr lang="nb-NO" smtClean="0"/>
              <a:t>19.12.2024</a:t>
            </a:fld>
            <a:endParaRPr lang="nb-NO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CD4655F-4D23-3751-D325-8EA9E83216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34F1CC2-986C-67B9-0E52-FA83AB8D94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DB7E0B-4246-46E5-8ABC-BFE1B36A0C8D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877033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93E639D-DBDE-04D4-9F17-54247F6461F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277E3F08-5588-4444-EDC6-CE0845DD294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b-NO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6C39786-3F0B-F3DB-B80D-CAD726C5ABB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0C246B9-F674-828B-D531-C9F6CF706F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B2135E-04AA-438E-B6D8-E2B4D8CF5484}" type="datetimeFigureOut">
              <a:rPr lang="nb-NO" smtClean="0"/>
              <a:t>19.12.2024</a:t>
            </a:fld>
            <a:endParaRPr lang="nb-NO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9EED9D4-4E53-AC05-5712-97E1680A01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122AE25-66AC-97F5-F682-ACB6A065CD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DB7E0B-4246-46E5-8ABC-BFE1B36A0C8D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1070948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93D30CB-CDBA-A568-B13D-32F751708B1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E0B0DD9-F610-67C3-C8F0-7F4C0CD6774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89C7CFE-7FCA-9F09-9A03-E339499F1EB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FB2135E-04AA-438E-B6D8-E2B4D8CF5484}" type="datetimeFigureOut">
              <a:rPr lang="nb-NO" smtClean="0"/>
              <a:t>19.12.2024</a:t>
            </a:fld>
            <a:endParaRPr lang="nb-NO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ADEB4E5-EA8E-030C-1F1B-E56E5291ADF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nb-NO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EAAA604-3A18-5C38-9C7C-B4717EB7931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2DB7E0B-4246-46E5-8ABC-BFE1B36A0C8D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641031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b-NO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 descr="undefined">
            <a:extLst>
              <a:ext uri="{FF2B5EF4-FFF2-40B4-BE49-F238E27FC236}">
                <a16:creationId xmlns:a16="http://schemas.microsoft.com/office/drawing/2014/main" id="{4BDAB2B6-CF5F-0207-0F13-B879E39EF06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36815" y="0"/>
            <a:ext cx="4849813" cy="6858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5E92B23A-A3D6-69C8-A2D9-408445CE9193}"/>
              </a:ext>
            </a:extLst>
          </p:cNvPr>
          <p:cNvSpPr txBox="1"/>
          <p:nvPr/>
        </p:nvSpPr>
        <p:spPr>
          <a:xfrm>
            <a:off x="5588228" y="6257836"/>
            <a:ext cx="6705372" cy="6001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nb-NO" sz="1100" dirty="0"/>
              <a:t>By Kommunal- og </a:t>
            </a:r>
            <a:r>
              <a:rPr lang="nb-NO" sz="1100" dirty="0" err="1"/>
              <a:t>distriktsdepartementet</a:t>
            </a:r>
            <a:r>
              <a:rPr lang="nb-NO" sz="1100" dirty="0"/>
              <a:t>/Planavdelingen - https://www.regjeringen.no/no/tema/kommuner-og-regioner/kommunestruktur/fylkesinndelingen-fra-2024/id2922222/, Public </a:t>
            </a:r>
            <a:r>
              <a:rPr lang="nb-NO" sz="1100" dirty="0" err="1"/>
              <a:t>Domain</a:t>
            </a:r>
            <a:r>
              <a:rPr lang="nb-NO" sz="1100" dirty="0"/>
              <a:t>, https://commons.wikimedia.org/w/index.php?curid=143352966</a:t>
            </a:r>
          </a:p>
        </p:txBody>
      </p:sp>
      <p:sp>
        <p:nvSpPr>
          <p:cNvPr id="6" name="Oval 5">
            <a:extLst>
              <a:ext uri="{FF2B5EF4-FFF2-40B4-BE49-F238E27FC236}">
                <a16:creationId xmlns:a16="http://schemas.microsoft.com/office/drawing/2014/main" id="{D7084186-2483-1AB6-DDFE-337C445537C1}"/>
              </a:ext>
            </a:extLst>
          </p:cNvPr>
          <p:cNvSpPr/>
          <p:nvPr/>
        </p:nvSpPr>
        <p:spPr>
          <a:xfrm>
            <a:off x="870857" y="5094515"/>
            <a:ext cx="696686" cy="275772"/>
          </a:xfrm>
          <a:prstGeom prst="ellipse">
            <a:avLst/>
          </a:prstGeom>
          <a:noFill/>
          <a:ln w="412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8" name="Oval 7">
            <a:extLst>
              <a:ext uri="{FF2B5EF4-FFF2-40B4-BE49-F238E27FC236}">
                <a16:creationId xmlns:a16="http://schemas.microsoft.com/office/drawing/2014/main" id="{923D9F66-D7B6-288A-5EC0-0AA28892EC08}"/>
              </a:ext>
            </a:extLst>
          </p:cNvPr>
          <p:cNvSpPr/>
          <p:nvPr/>
        </p:nvSpPr>
        <p:spPr>
          <a:xfrm>
            <a:off x="578758" y="6119950"/>
            <a:ext cx="696686" cy="275772"/>
          </a:xfrm>
          <a:prstGeom prst="ellipse">
            <a:avLst/>
          </a:prstGeom>
          <a:noFill/>
          <a:ln w="412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8988DE5B-533F-9B71-60F8-5971733079EE}"/>
              </a:ext>
            </a:extLst>
          </p:cNvPr>
          <p:cNvSpPr txBox="1"/>
          <p:nvPr/>
        </p:nvSpPr>
        <p:spPr>
          <a:xfrm>
            <a:off x="5805714" y="1074057"/>
            <a:ext cx="5544457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 err="1"/>
              <a:t>Map</a:t>
            </a:r>
            <a:r>
              <a:rPr lang="nb-NO" dirty="0"/>
              <a:t> of Norway </a:t>
            </a:r>
            <a:r>
              <a:rPr lang="nb-NO" dirty="0" err="1"/>
              <a:t>showing</a:t>
            </a:r>
            <a:r>
              <a:rPr lang="nb-NO" dirty="0"/>
              <a:t> </a:t>
            </a:r>
            <a:r>
              <a:rPr lang="nb-NO" dirty="0" err="1"/>
              <a:t>counties</a:t>
            </a:r>
            <a:r>
              <a:rPr lang="nb-NO" dirty="0"/>
              <a:t>, </a:t>
            </a:r>
            <a:r>
              <a:rPr lang="nb-NO" dirty="0" err="1"/>
              <a:t>with</a:t>
            </a:r>
            <a:r>
              <a:rPr lang="nb-NO" dirty="0"/>
              <a:t> </a:t>
            </a:r>
            <a:r>
              <a:rPr lang="nb-NO" dirty="0" err="1"/>
              <a:t>Vestland</a:t>
            </a:r>
            <a:r>
              <a:rPr lang="nb-NO" dirty="0"/>
              <a:t> and Rogaland (</a:t>
            </a:r>
            <a:r>
              <a:rPr lang="nb-NO" dirty="0" err="1"/>
              <a:t>counties</a:t>
            </a:r>
            <a:r>
              <a:rPr lang="nb-NO" dirty="0"/>
              <a:t> </a:t>
            </a:r>
            <a:r>
              <a:rPr lang="nb-NO" dirty="0" err="1"/>
              <a:t>where</a:t>
            </a:r>
            <a:r>
              <a:rPr lang="nb-NO" dirty="0"/>
              <a:t> </a:t>
            </a:r>
            <a:r>
              <a:rPr lang="nb-NO" dirty="0" err="1"/>
              <a:t>lambs</a:t>
            </a:r>
            <a:r>
              <a:rPr lang="nb-NO" dirty="0"/>
              <a:t> </a:t>
            </a:r>
            <a:r>
              <a:rPr lang="nb-NO" dirty="0" err="1"/>
              <a:t>were</a:t>
            </a:r>
            <a:r>
              <a:rPr lang="nb-NO" dirty="0"/>
              <a:t> </a:t>
            </a:r>
            <a:r>
              <a:rPr lang="nb-NO" dirty="0" err="1"/>
              <a:t>sampled</a:t>
            </a:r>
            <a:r>
              <a:rPr lang="nb-NO" dirty="0"/>
              <a:t>) </a:t>
            </a:r>
            <a:r>
              <a:rPr lang="nb-NO" dirty="0" err="1"/>
              <a:t>ringed</a:t>
            </a:r>
            <a:r>
              <a:rPr lang="nb-NO"/>
              <a:t> in red.</a:t>
            </a:r>
          </a:p>
        </p:txBody>
      </p:sp>
    </p:spTree>
    <p:extLst>
      <p:ext uri="{BB962C8B-B14F-4D97-AF65-F5344CB8AC3E}">
        <p14:creationId xmlns:p14="http://schemas.microsoft.com/office/powerpoint/2010/main" val="339683334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8</Words>
  <Application>Microsoft Office PowerPoint</Application>
  <PresentationFormat>Widescreen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Lucy Robertson</dc:creator>
  <cp:lastModifiedBy>Lucy Robertson</cp:lastModifiedBy>
  <cp:revision>1</cp:revision>
  <dcterms:created xsi:type="dcterms:W3CDTF">2024-12-19T12:00:02Z</dcterms:created>
  <dcterms:modified xsi:type="dcterms:W3CDTF">2024-12-19T12:05:0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d0484126-3486-41a9-802e-7f1e2277276c_Enabled">
    <vt:lpwstr>true</vt:lpwstr>
  </property>
  <property fmtid="{D5CDD505-2E9C-101B-9397-08002B2CF9AE}" pid="3" name="MSIP_Label_d0484126-3486-41a9-802e-7f1e2277276c_SetDate">
    <vt:lpwstr>2024-12-19T12:05:07Z</vt:lpwstr>
  </property>
  <property fmtid="{D5CDD505-2E9C-101B-9397-08002B2CF9AE}" pid="4" name="MSIP_Label_d0484126-3486-41a9-802e-7f1e2277276c_Method">
    <vt:lpwstr>Standard</vt:lpwstr>
  </property>
  <property fmtid="{D5CDD505-2E9C-101B-9397-08002B2CF9AE}" pid="5" name="MSIP_Label_d0484126-3486-41a9-802e-7f1e2277276c_Name">
    <vt:lpwstr>d0484126-3486-41a9-802e-7f1e2277276c</vt:lpwstr>
  </property>
  <property fmtid="{D5CDD505-2E9C-101B-9397-08002B2CF9AE}" pid="6" name="MSIP_Label_d0484126-3486-41a9-802e-7f1e2277276c_SiteId">
    <vt:lpwstr>eec01f8e-737f-43e3-9ed5-f8a59913bd82</vt:lpwstr>
  </property>
  <property fmtid="{D5CDD505-2E9C-101B-9397-08002B2CF9AE}" pid="7" name="MSIP_Label_d0484126-3486-41a9-802e-7f1e2277276c_ActionId">
    <vt:lpwstr>683401d4-cf9d-4ed4-8930-fd3ad45d0cb8</vt:lpwstr>
  </property>
  <property fmtid="{D5CDD505-2E9C-101B-9397-08002B2CF9AE}" pid="8" name="MSIP_Label_d0484126-3486-41a9-802e-7f1e2277276c_ContentBits">
    <vt:lpwstr>0</vt:lpwstr>
  </property>
</Properties>
</file>